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43"/>
  </p:normalViewPr>
  <p:slideViewPr>
    <p:cSldViewPr snapToGrid="0" snapToObjects="1">
      <p:cViewPr>
        <p:scale>
          <a:sx n="110" d="100"/>
          <a:sy n="110" d="100"/>
        </p:scale>
        <p:origin x="754" y="725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203B9A43-C5AF-0741-BFB9-E32DD0377C0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Подзаголовок 2">
            <a:extLst>
              <a:ext uri="{FF2B5EF4-FFF2-40B4-BE49-F238E27FC236}">
                <a16:creationId xmlns="" xmlns:a16="http://schemas.microsoft.com/office/drawing/2014/main" id="{2C867690-B595-FE4B-A916-1DF560821F0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ru-RU"/>
              <a:t>Образец подзаголовка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E8AF11A2-2438-4F4B-A67D-8FAAA949D2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07D11-D53C-C840-9008-9C6383009974}" type="datetimeFigureOut">
              <a:rPr lang="en-US"/>
              <a:pPr/>
              <a:t>1/31/2021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BC688B5E-19D4-9F4D-BFF1-9C91D264C3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508D32C3-D8F8-3343-9DC5-21F497B150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F74EE-C5A9-AE42-8657-BF717CA59D1D}" type="slidenum">
              <a:rPr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="" xmlns:p14="http://schemas.microsoft.com/office/powerpoint/2010/main" val="40933654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A4ABA85A-AE2F-4149-A2AF-DD3E192CC3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>
            <a:extLst>
              <a:ext uri="{FF2B5EF4-FFF2-40B4-BE49-F238E27FC236}">
                <a16:creationId xmlns="" xmlns:a16="http://schemas.microsoft.com/office/drawing/2014/main" id="{C7ECC175-7A3F-324C-8DFE-BA1EC12F923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44494510-11BB-A140-9743-E5DC123B24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07D11-D53C-C840-9008-9C6383009974}" type="datetimeFigureOut">
              <a:rPr lang="en-US"/>
              <a:pPr/>
              <a:t>1/31/2021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32B0A960-D008-5D40-9F29-B0E107660A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0831EAB2-1C51-3345-918D-7C10A33347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F74EE-C5A9-AE42-8657-BF717CA59D1D}" type="slidenum">
              <a:rPr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="" xmlns:p14="http://schemas.microsoft.com/office/powerpoint/2010/main" val="31756889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>
            <a:extLst>
              <a:ext uri="{FF2B5EF4-FFF2-40B4-BE49-F238E27FC236}">
                <a16:creationId xmlns="" xmlns:a16="http://schemas.microsoft.com/office/drawing/2014/main" id="{C0102CFC-74F6-EC4C-9FF4-1DEBEFFA7BF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>
            <a:extLst>
              <a:ext uri="{FF2B5EF4-FFF2-40B4-BE49-F238E27FC236}">
                <a16:creationId xmlns="" xmlns:a16="http://schemas.microsoft.com/office/drawing/2014/main" id="{E7F0FA73-1610-F24B-BA9A-A7D15A29EEA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734ADBBB-D1CF-0245-B349-FFDF26ADAB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07D11-D53C-C840-9008-9C6383009974}" type="datetimeFigureOut">
              <a:rPr lang="en-US"/>
              <a:pPr/>
              <a:t>1/31/2021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043E5D58-8EF5-9D40-8703-B5D8750C21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7B2189D1-39B6-BD40-8C79-28766EFE1C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F74EE-C5A9-AE42-8657-BF717CA59D1D}" type="slidenum">
              <a:rPr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="" xmlns:p14="http://schemas.microsoft.com/office/powerpoint/2010/main" val="2265981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E2DA2104-C14A-5843-A07C-0231DED4B1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="" xmlns:a16="http://schemas.microsoft.com/office/drawing/2014/main" id="{B13489A6-145F-9E40-8CFA-A885312F06A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B3F468DB-F0A4-4043-8865-EFD0FE48DA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07D11-D53C-C840-9008-9C6383009974}" type="datetimeFigureOut">
              <a:rPr lang="en-US"/>
              <a:pPr/>
              <a:t>1/31/2021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086F598E-FD7D-BB4D-A12E-694C792CA5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09C683F5-48A7-6B46-B8BF-BB346584B3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F74EE-C5A9-AE42-8657-BF717CA59D1D}" type="slidenum">
              <a:rPr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="" xmlns:p14="http://schemas.microsoft.com/office/powerpoint/2010/main" val="14805844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F251A077-50F4-6B40-8089-6DA43666BA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Текст 2">
            <a:extLst>
              <a:ext uri="{FF2B5EF4-FFF2-40B4-BE49-F238E27FC236}">
                <a16:creationId xmlns="" xmlns:a16="http://schemas.microsoft.com/office/drawing/2014/main" id="{F31457EC-DFAD-264B-9031-D910F8D52B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031BD898-8064-3D4F-9E9B-C75B15812A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07D11-D53C-C840-9008-9C6383009974}" type="datetimeFigureOut">
              <a:rPr lang="en-US"/>
              <a:pPr/>
              <a:t>1/31/2021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D461F090-E3E4-B84C-B776-F28CA65431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4DD68F0F-9298-1040-B66D-F014BAF457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F74EE-C5A9-AE42-8657-BF717CA59D1D}" type="slidenum">
              <a:rPr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="" xmlns:p14="http://schemas.microsoft.com/office/powerpoint/2010/main" val="29954636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97DC9055-D1EA-5E4A-AE41-57BB8EA29B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="" xmlns:a16="http://schemas.microsoft.com/office/drawing/2014/main" id="{15F1FB56-9D56-F34A-B5F6-2121A3317D4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Объект 3">
            <a:extLst>
              <a:ext uri="{FF2B5EF4-FFF2-40B4-BE49-F238E27FC236}">
                <a16:creationId xmlns="" xmlns:a16="http://schemas.microsoft.com/office/drawing/2014/main" id="{FE395EC3-92F1-6046-992B-8C44F058F64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Дата 4">
            <a:extLst>
              <a:ext uri="{FF2B5EF4-FFF2-40B4-BE49-F238E27FC236}">
                <a16:creationId xmlns="" xmlns:a16="http://schemas.microsoft.com/office/drawing/2014/main" id="{32F753B7-0BDB-EF4E-8488-37C6117C59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07D11-D53C-C840-9008-9C6383009974}" type="datetimeFigureOut">
              <a:rPr lang="en-US"/>
              <a:pPr/>
              <a:t>1/31/2021</a:t>
            </a:fld>
            <a:endParaRPr lang="ru-RU"/>
          </a:p>
        </p:txBody>
      </p:sp>
      <p:sp>
        <p:nvSpPr>
          <p:cNvPr id="6" name="Нижний колонтитул 5">
            <a:extLst>
              <a:ext uri="{FF2B5EF4-FFF2-40B4-BE49-F238E27FC236}">
                <a16:creationId xmlns="" xmlns:a16="http://schemas.microsoft.com/office/drawing/2014/main" id="{8F80F89C-84D5-2747-8DD3-E12309E802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>
            <a:extLst>
              <a:ext uri="{FF2B5EF4-FFF2-40B4-BE49-F238E27FC236}">
                <a16:creationId xmlns="" xmlns:a16="http://schemas.microsoft.com/office/drawing/2014/main" id="{E6BDC829-D7C4-0045-89B9-44210D6088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F74EE-C5A9-AE42-8657-BF717CA59D1D}" type="slidenum">
              <a:rPr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="" xmlns:p14="http://schemas.microsoft.com/office/powerpoint/2010/main" val="18664999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6AE7F793-AEC2-B246-8668-D3E8528BCF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Текст 2">
            <a:extLst>
              <a:ext uri="{FF2B5EF4-FFF2-40B4-BE49-F238E27FC236}">
                <a16:creationId xmlns="" xmlns:a16="http://schemas.microsoft.com/office/drawing/2014/main" id="{96582490-D485-5749-A975-AD2B2748FE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Объект 3">
            <a:extLst>
              <a:ext uri="{FF2B5EF4-FFF2-40B4-BE49-F238E27FC236}">
                <a16:creationId xmlns="" xmlns:a16="http://schemas.microsoft.com/office/drawing/2014/main" id="{3CD4208C-B7F7-EC40-B942-96A4EA92AD0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Текст 4">
            <a:extLst>
              <a:ext uri="{FF2B5EF4-FFF2-40B4-BE49-F238E27FC236}">
                <a16:creationId xmlns="" xmlns:a16="http://schemas.microsoft.com/office/drawing/2014/main" id="{F12C2F13-8D36-0F4A-870C-D316452AEC6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6" name="Объект 5">
            <a:extLst>
              <a:ext uri="{FF2B5EF4-FFF2-40B4-BE49-F238E27FC236}">
                <a16:creationId xmlns="" xmlns:a16="http://schemas.microsoft.com/office/drawing/2014/main" id="{BF66DDC6-B088-4C46-8551-3939BC5AFDB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7" name="Дата 6">
            <a:extLst>
              <a:ext uri="{FF2B5EF4-FFF2-40B4-BE49-F238E27FC236}">
                <a16:creationId xmlns="" xmlns:a16="http://schemas.microsoft.com/office/drawing/2014/main" id="{166C2FA9-D828-4946-914C-9852C8301B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07D11-D53C-C840-9008-9C6383009974}" type="datetimeFigureOut">
              <a:rPr lang="en-US"/>
              <a:pPr/>
              <a:t>1/31/2021</a:t>
            </a:fld>
            <a:endParaRPr lang="ru-RU"/>
          </a:p>
        </p:txBody>
      </p:sp>
      <p:sp>
        <p:nvSpPr>
          <p:cNvPr id="8" name="Нижний колонтитул 7">
            <a:extLst>
              <a:ext uri="{FF2B5EF4-FFF2-40B4-BE49-F238E27FC236}">
                <a16:creationId xmlns="" xmlns:a16="http://schemas.microsoft.com/office/drawing/2014/main" id="{A3A7D2D8-9235-C24F-B161-24DD0DEC38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>
            <a:extLst>
              <a:ext uri="{FF2B5EF4-FFF2-40B4-BE49-F238E27FC236}">
                <a16:creationId xmlns="" xmlns:a16="http://schemas.microsoft.com/office/drawing/2014/main" id="{4AFADCC9-F507-E541-AE67-5B0FAB9D09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F74EE-C5A9-AE42-8657-BF717CA59D1D}" type="slidenum">
              <a:rPr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="" xmlns:p14="http://schemas.microsoft.com/office/powerpoint/2010/main" val="14005819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C2DC5765-6C68-5A43-B812-8BF62DF52F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Дата 2">
            <a:extLst>
              <a:ext uri="{FF2B5EF4-FFF2-40B4-BE49-F238E27FC236}">
                <a16:creationId xmlns="" xmlns:a16="http://schemas.microsoft.com/office/drawing/2014/main" id="{9CF2C96D-4B4B-E446-B61B-4EFCFA65D6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07D11-D53C-C840-9008-9C6383009974}" type="datetimeFigureOut">
              <a:rPr lang="en-US"/>
              <a:pPr/>
              <a:t>1/31/2021</a:t>
            </a:fld>
            <a:endParaRPr lang="ru-RU"/>
          </a:p>
        </p:txBody>
      </p:sp>
      <p:sp>
        <p:nvSpPr>
          <p:cNvPr id="4" name="Нижний колонтитул 3">
            <a:extLst>
              <a:ext uri="{FF2B5EF4-FFF2-40B4-BE49-F238E27FC236}">
                <a16:creationId xmlns="" xmlns:a16="http://schemas.microsoft.com/office/drawing/2014/main" id="{31E3FD99-26F9-3340-AD55-73712E937A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>
            <a:extLst>
              <a:ext uri="{FF2B5EF4-FFF2-40B4-BE49-F238E27FC236}">
                <a16:creationId xmlns="" xmlns:a16="http://schemas.microsoft.com/office/drawing/2014/main" id="{64011E21-AA14-0F4A-8516-20BF2020FE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F74EE-C5A9-AE42-8657-BF717CA59D1D}" type="slidenum">
              <a:rPr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="" xmlns:p14="http://schemas.microsoft.com/office/powerpoint/2010/main" val="11746518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>
            <a:extLst>
              <a:ext uri="{FF2B5EF4-FFF2-40B4-BE49-F238E27FC236}">
                <a16:creationId xmlns="" xmlns:a16="http://schemas.microsoft.com/office/drawing/2014/main" id="{879618BF-C6DD-494F-8FB2-03EB4185CC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07D11-D53C-C840-9008-9C6383009974}" type="datetimeFigureOut">
              <a:rPr lang="en-US"/>
              <a:pPr/>
              <a:t>1/31/2021</a:t>
            </a:fld>
            <a:endParaRPr lang="ru-RU"/>
          </a:p>
        </p:txBody>
      </p:sp>
      <p:sp>
        <p:nvSpPr>
          <p:cNvPr id="3" name="Нижний колонтитул 2">
            <a:extLst>
              <a:ext uri="{FF2B5EF4-FFF2-40B4-BE49-F238E27FC236}">
                <a16:creationId xmlns="" xmlns:a16="http://schemas.microsoft.com/office/drawing/2014/main" id="{C4AE5E4C-BD39-DE41-ABE3-84AEF8D9D6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>
            <a:extLst>
              <a:ext uri="{FF2B5EF4-FFF2-40B4-BE49-F238E27FC236}">
                <a16:creationId xmlns="" xmlns:a16="http://schemas.microsoft.com/office/drawing/2014/main" id="{03E95593-4061-D341-9C2E-505943B375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F74EE-C5A9-AE42-8657-BF717CA59D1D}" type="slidenum">
              <a:rPr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="" xmlns:p14="http://schemas.microsoft.com/office/powerpoint/2010/main" val="21199905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B5C0E384-BFD0-D14E-813B-B610988F64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="" xmlns:a16="http://schemas.microsoft.com/office/drawing/2014/main" id="{94D7E92E-DCCA-8B48-BE59-10973DC3B63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Текст 3">
            <a:extLst>
              <a:ext uri="{FF2B5EF4-FFF2-40B4-BE49-F238E27FC236}">
                <a16:creationId xmlns="" xmlns:a16="http://schemas.microsoft.com/office/drawing/2014/main" id="{05DAE1DD-F99A-CF44-9907-B5086C65A93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Дата 4">
            <a:extLst>
              <a:ext uri="{FF2B5EF4-FFF2-40B4-BE49-F238E27FC236}">
                <a16:creationId xmlns="" xmlns:a16="http://schemas.microsoft.com/office/drawing/2014/main" id="{3791C2E9-909A-4443-BB43-3AD676CAC6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07D11-D53C-C840-9008-9C6383009974}" type="datetimeFigureOut">
              <a:rPr lang="en-US"/>
              <a:pPr/>
              <a:t>1/31/2021</a:t>
            </a:fld>
            <a:endParaRPr lang="ru-RU"/>
          </a:p>
        </p:txBody>
      </p:sp>
      <p:sp>
        <p:nvSpPr>
          <p:cNvPr id="6" name="Нижний колонтитул 5">
            <a:extLst>
              <a:ext uri="{FF2B5EF4-FFF2-40B4-BE49-F238E27FC236}">
                <a16:creationId xmlns="" xmlns:a16="http://schemas.microsoft.com/office/drawing/2014/main" id="{7A142BEA-0289-044F-ABCC-BB6250BBCC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>
            <a:extLst>
              <a:ext uri="{FF2B5EF4-FFF2-40B4-BE49-F238E27FC236}">
                <a16:creationId xmlns="" xmlns:a16="http://schemas.microsoft.com/office/drawing/2014/main" id="{DCAF7283-45D6-F244-A052-EBF66B9F88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F74EE-C5A9-AE42-8657-BF717CA59D1D}" type="slidenum">
              <a:rPr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="" xmlns:p14="http://schemas.microsoft.com/office/powerpoint/2010/main" val="16586240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2867E3A1-D54F-A64E-BFF7-6BD7542271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Рисунок 2">
            <a:extLst>
              <a:ext uri="{FF2B5EF4-FFF2-40B4-BE49-F238E27FC236}">
                <a16:creationId xmlns="" xmlns:a16="http://schemas.microsoft.com/office/drawing/2014/main" id="{A01303BB-C29B-0449-A29D-6DECD806047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>
            <a:extLst>
              <a:ext uri="{FF2B5EF4-FFF2-40B4-BE49-F238E27FC236}">
                <a16:creationId xmlns="" xmlns:a16="http://schemas.microsoft.com/office/drawing/2014/main" id="{493D4BCF-0A2B-6B49-BE1D-98E04B42B05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Дата 4">
            <a:extLst>
              <a:ext uri="{FF2B5EF4-FFF2-40B4-BE49-F238E27FC236}">
                <a16:creationId xmlns="" xmlns:a16="http://schemas.microsoft.com/office/drawing/2014/main" id="{E1242A6E-768F-F048-AE27-ADBE1B7D05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07D11-D53C-C840-9008-9C6383009974}" type="datetimeFigureOut">
              <a:rPr lang="en-US"/>
              <a:pPr/>
              <a:t>1/31/2021</a:t>
            </a:fld>
            <a:endParaRPr lang="ru-RU"/>
          </a:p>
        </p:txBody>
      </p:sp>
      <p:sp>
        <p:nvSpPr>
          <p:cNvPr id="6" name="Нижний колонтитул 5">
            <a:extLst>
              <a:ext uri="{FF2B5EF4-FFF2-40B4-BE49-F238E27FC236}">
                <a16:creationId xmlns="" xmlns:a16="http://schemas.microsoft.com/office/drawing/2014/main" id="{7C3B28BC-207A-164A-AC69-97B481C697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>
            <a:extLst>
              <a:ext uri="{FF2B5EF4-FFF2-40B4-BE49-F238E27FC236}">
                <a16:creationId xmlns="" xmlns:a16="http://schemas.microsoft.com/office/drawing/2014/main" id="{74C90D61-FF1E-3248-956F-5A4F861E9B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F74EE-C5A9-AE42-8657-BF717CA59D1D}" type="slidenum">
              <a:rPr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="" xmlns:p14="http://schemas.microsoft.com/office/powerpoint/2010/main" val="42550985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5DA992B9-4C5D-5847-8C6E-6396697528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Текст 2">
            <a:extLst>
              <a:ext uri="{FF2B5EF4-FFF2-40B4-BE49-F238E27FC236}">
                <a16:creationId xmlns="" xmlns:a16="http://schemas.microsoft.com/office/drawing/2014/main" id="{6D1F65FE-4D94-654F-BB31-7F4A47D035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471A72B2-2518-8B49-9B3F-4143C54CA0D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C07D11-D53C-C840-9008-9C6383009974}" type="datetimeFigureOut">
              <a:rPr lang="en-US"/>
              <a:pPr/>
              <a:t>1/31/2021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D5BC9C57-3562-1043-AFB1-9D2ACA3E9B2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D3A27AD1-F8F0-3741-8E31-38474CA1CCB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DF74EE-C5A9-AE42-8657-BF717CA59D1D}" type="slidenum">
              <a:rPr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="" xmlns:p14="http://schemas.microsoft.com/office/powerpoint/2010/main" val="41053968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Рисунок 11">
            <a:extLst>
              <a:ext uri="{FF2B5EF4-FFF2-40B4-BE49-F238E27FC236}">
                <a16:creationId xmlns="" xmlns:a16="http://schemas.microsoft.com/office/drawing/2014/main" id="{41A7664C-CD8C-9B43-9FF8-64643E033E3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05892" y="1432809"/>
            <a:ext cx="5390344" cy="3131976"/>
          </a:xfrm>
          <a:prstGeom prst="rect">
            <a:avLst/>
          </a:prstGeom>
        </p:spPr>
      </p:pic>
      <p:sp>
        <p:nvSpPr>
          <p:cNvPr id="15" name="Открывающая фигурная скобка 14">
            <a:extLst>
              <a:ext uri="{FF2B5EF4-FFF2-40B4-BE49-F238E27FC236}">
                <a16:creationId xmlns="" xmlns:a16="http://schemas.microsoft.com/office/drawing/2014/main" id="{46EADF0A-6DF4-A043-B2C7-0F9804E883A1}"/>
              </a:ext>
            </a:extLst>
          </p:cNvPr>
          <p:cNvSpPr/>
          <p:nvPr/>
        </p:nvSpPr>
        <p:spPr>
          <a:xfrm rot="16200000">
            <a:off x="7057524" y="3803625"/>
            <a:ext cx="211722" cy="2116958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16" name="TextBox 15">
            <a:extLst>
              <a:ext uri="{FF2B5EF4-FFF2-40B4-BE49-F238E27FC236}">
                <a16:creationId xmlns="" xmlns:a16="http://schemas.microsoft.com/office/drawing/2014/main" id="{77C73EBF-782F-B145-9B59-16C2420E14DE}"/>
              </a:ext>
            </a:extLst>
          </p:cNvPr>
          <p:cNvSpPr txBox="1"/>
          <p:nvPr/>
        </p:nvSpPr>
        <p:spPr>
          <a:xfrm>
            <a:off x="6380535" y="5007600"/>
            <a:ext cx="2565229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ts to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ishmania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romosomes </a:t>
            </a:r>
          </a:p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</a:t>
            </a:r>
            <a:r>
              <a:rPr lang="en-US" sz="16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Β-TUBULIN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annotations</a:t>
            </a:r>
            <a:endParaRPr lang="ru-RU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Открывающая фигурная скобка 16">
            <a:extLst>
              <a:ext uri="{FF2B5EF4-FFF2-40B4-BE49-F238E27FC236}">
                <a16:creationId xmlns="" xmlns:a16="http://schemas.microsoft.com/office/drawing/2014/main" id="{988E8A5E-95A0-BA40-8525-46C67D051654}"/>
              </a:ext>
            </a:extLst>
          </p:cNvPr>
          <p:cNvSpPr/>
          <p:nvPr/>
        </p:nvSpPr>
        <p:spPr>
          <a:xfrm rot="16200000">
            <a:off x="4105871" y="4060508"/>
            <a:ext cx="211723" cy="1611681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18" name="TextBox 17">
            <a:extLst>
              <a:ext uri="{FF2B5EF4-FFF2-40B4-BE49-F238E27FC236}">
                <a16:creationId xmlns="" xmlns:a16="http://schemas.microsoft.com/office/drawing/2014/main" id="{D9239F9F-FF27-F34B-A7E7-9ECDB8B7ECC6}"/>
              </a:ext>
            </a:extLst>
          </p:cNvPr>
          <p:cNvSpPr txBox="1"/>
          <p:nvPr/>
        </p:nvSpPr>
        <p:spPr>
          <a:xfrm>
            <a:off x="3338475" y="5007600"/>
            <a:ext cx="2676633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ts to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ishmania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hromosomes </a:t>
            </a:r>
          </a:p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</a:t>
            </a:r>
            <a:r>
              <a:rPr lang="en-US" sz="16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Β-TUBULIN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notations</a:t>
            </a:r>
            <a:endParaRPr lang="ru-RU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Открывающая фигурная скобка 18">
            <a:extLst>
              <a:ext uri="{FF2B5EF4-FFF2-40B4-BE49-F238E27FC236}">
                <a16:creationId xmlns="" xmlns:a16="http://schemas.microsoft.com/office/drawing/2014/main" id="{DDDDD65D-48B4-B44F-8258-F533F430899B}"/>
              </a:ext>
            </a:extLst>
          </p:cNvPr>
          <p:cNvSpPr/>
          <p:nvPr/>
        </p:nvSpPr>
        <p:spPr>
          <a:xfrm rot="16200000">
            <a:off x="5491770" y="4518036"/>
            <a:ext cx="242684" cy="689691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20" name="TextBox 19">
            <a:extLst>
              <a:ext uri="{FF2B5EF4-FFF2-40B4-BE49-F238E27FC236}">
                <a16:creationId xmlns="" xmlns:a16="http://schemas.microsoft.com/office/drawing/2014/main" id="{1537019A-51D3-0745-9FD3-23A9D26E8AE6}"/>
              </a:ext>
            </a:extLst>
          </p:cNvPr>
          <p:cNvSpPr txBox="1"/>
          <p:nvPr/>
        </p:nvSpPr>
        <p:spPr>
          <a:xfrm>
            <a:off x="5039066" y="5006662"/>
            <a:ext cx="137794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i="1" dirty="0" smtClean="0">
                <a:latin typeface="Times New Roman" pitchFamily="18" charset="0"/>
                <a:cs typeface="Times New Roman" pitchFamily="18" charset="0"/>
              </a:rPr>
              <a:t>SAT::2A::CAT</a:t>
            </a:r>
          </a:p>
          <a:p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sequence </a:t>
            </a:r>
            <a:endParaRPr lang="ru-RU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="" xmlns:a16="http://schemas.microsoft.com/office/drawing/2014/main" id="{533F9AEC-85ED-9543-9077-2962B65D07D3}"/>
              </a:ext>
            </a:extLst>
          </p:cNvPr>
          <p:cNvSpPr txBox="1"/>
          <p:nvPr/>
        </p:nvSpPr>
        <p:spPr>
          <a:xfrm>
            <a:off x="3552714" y="1114611"/>
            <a:ext cx="453797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dirty="0" err="1" smtClean="0">
                <a:latin typeface="Times New Roman" pitchFamily="18" charset="0"/>
                <a:cs typeface="Times New Roman" pitchFamily="18" charset="0"/>
              </a:rPr>
              <a:t>PacBio</a:t>
            </a:r>
            <a:r>
              <a:rPr lang="en-US" sz="20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2000" dirty="0">
                <a:latin typeface="Times New Roman" pitchFamily="18" charset="0"/>
                <a:cs typeface="Times New Roman" pitchFamily="18" charset="0"/>
              </a:rPr>
              <a:t>read with </a:t>
            </a:r>
            <a:r>
              <a:rPr lang="en-US" sz="2000" i="1" dirty="0" smtClean="0">
                <a:latin typeface="Times New Roman" pitchFamily="18" charset="0"/>
                <a:cs typeface="Times New Roman" pitchFamily="18" charset="0"/>
              </a:rPr>
              <a:t>SAT::2A::CAT </a:t>
            </a:r>
            <a:r>
              <a:rPr lang="en-US" sz="2000" dirty="0">
                <a:latin typeface="Times New Roman" pitchFamily="18" charset="0"/>
                <a:cs typeface="Times New Roman" pitchFamily="18" charset="0"/>
              </a:rPr>
              <a:t>construct</a:t>
            </a:r>
            <a:endParaRPr lang="ru-RU" sz="20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3" name="Прямая со стрелкой 22">
            <a:extLst>
              <a:ext uri="{FF2B5EF4-FFF2-40B4-BE49-F238E27FC236}">
                <a16:creationId xmlns="" xmlns:a16="http://schemas.microsoft.com/office/drawing/2014/main" id="{666B9B46-A0DD-4746-B8DB-D72B7382D810}"/>
              </a:ext>
            </a:extLst>
          </p:cNvPr>
          <p:cNvCxnSpPr>
            <a:cxnSpLocks/>
          </p:cNvCxnSpPr>
          <p:nvPr/>
        </p:nvCxnSpPr>
        <p:spPr>
          <a:xfrm flipH="1">
            <a:off x="5816354" y="3633980"/>
            <a:ext cx="1551520" cy="0"/>
          </a:xfrm>
          <a:prstGeom prst="straightConnector1">
            <a:avLst/>
          </a:prstGeom>
          <a:ln w="28575">
            <a:solidFill>
              <a:schemeClr val="accent6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="" xmlns:a16="http://schemas.microsoft.com/office/drawing/2014/main" id="{FA7DD187-5380-8B40-9D56-79A7B64343B2}"/>
              </a:ext>
            </a:extLst>
          </p:cNvPr>
          <p:cNvSpPr txBox="1"/>
          <p:nvPr/>
        </p:nvSpPr>
        <p:spPr>
          <a:xfrm>
            <a:off x="7349619" y="3414589"/>
            <a:ext cx="225843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i="1" dirty="0" smtClean="0">
                <a:latin typeface="Times New Roman" pitchFamily="18" charset="0"/>
                <a:cs typeface="Times New Roman" pitchFamily="18" charset="0"/>
              </a:rPr>
              <a:t>Leptomonas </a:t>
            </a:r>
            <a:r>
              <a:rPr lang="en-US" sz="1600" i="1" dirty="0" smtClean="0">
                <a:latin typeface="Times New Roman" pitchFamily="18" charset="0"/>
                <a:cs typeface="Times New Roman" pitchFamily="18" charset="0"/>
              </a:rPr>
              <a:t>pyrrhocoris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en-US" sz="1600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catalase 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hits</a:t>
            </a:r>
            <a:endParaRPr lang="ru-RU" sz="16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1187720847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Стандартная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3</TotalTime>
  <Words>34</Words>
  <Application>Microsoft Office PowerPoint</Application>
  <PresentationFormat>Произвольный</PresentationFormat>
  <Paragraphs>10</Paragraphs>
  <Slides>1</Slides>
  <Notes>0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Тема Office</vt:lpstr>
      <vt:lpstr>Слайд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Gerasimov Evgeny</dc:creator>
  <cp:lastModifiedBy>Yury</cp:lastModifiedBy>
  <cp:revision>18</cp:revision>
  <dcterms:created xsi:type="dcterms:W3CDTF">2020-05-04T08:52:53Z</dcterms:created>
  <dcterms:modified xsi:type="dcterms:W3CDTF">2021-01-31T22:07:28Z</dcterms:modified>
</cp:coreProperties>
</file>